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09C4C2-2B65-0B76-8398-866A00DDB8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F7673D-EF6D-20D5-7CAC-74F343381C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20DD7B-35D3-B476-22EB-C05F14780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D70E38-5F08-2E33-35FE-3893BC19B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553DAA-056C-5765-7A85-6475D3DA0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817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370A61-2510-BC19-FC14-749446FD58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4E9566-E09E-CCDD-BD70-CF6B85ACA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4D6B90-4ACF-00E7-CC36-23CAC9D12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EC8F94-F234-A0A9-9712-DDB519DE6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2902E-3A24-0704-9F50-3BFE89F2D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548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656731-4385-D688-33D1-04B0A26815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6331D-BDA8-B642-E1D6-70F2A156E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031BDD-FC5B-0649-260B-F9990C008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9537B-8D2C-76C4-1755-7BD5DDBF6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B6FBF3-B9CB-0F2F-B86C-E7B60B62F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880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3CD1B1-B7C5-39D5-9837-9B0DDC268F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3AEA5F-A1D8-FD26-0A75-9D82950E7C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F94B15-15BB-4043-6706-FB54B39E5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D0513D-D88D-337A-3485-ACC87197A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C52A2A-C897-051C-A203-E1C83F801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956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0BF4A5-93BF-D952-4674-25D14FE02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CBE484-738F-52BF-96EE-A1567C3C5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F279E0-7F48-CE12-4CD2-DDBDE44EC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8C3A76-3843-B85B-3E1A-B34DB6AF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5E894F-3C21-715C-DE8B-5B844BE23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02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B6975-A8BA-CAB6-AFCE-AD189BD257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E77DAD-B3DD-9521-D37F-2BED16C97E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A53474-2E78-2FC3-8642-0DC0C42D57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F4065-96DB-D59C-6591-7B795A3C8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F87336-6062-9592-3BEC-0A61BA5BE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4D89B-4AAD-C5BE-5E6F-6DA82BCD0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33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9C3C0-31FD-CF83-36CE-7C463CFEE8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5C1C1E-4916-2A28-C205-5D4EC63178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512478-30CC-BA7E-1F28-E038A0A43B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E56552-935E-F4E0-C3BD-68188B489C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AD47F1-E55B-9363-25F4-1F5AC10A65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CCA48D-F07E-164B-7229-342866497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8B2D53-0795-E9E5-E54C-3D8F0A242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D22F7A-C838-CBB4-0B13-C0FCE83E0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296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21AA6B-DCFF-E72C-AFB0-8A69B5D9E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5D579B-415A-571E-A6C6-F107F1E18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E6D123-262E-3031-FC3C-A4A602E94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C87666-1C47-2E83-07A4-BD0D31ED0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00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03E7F0-595A-1BA3-BCED-B05F04C64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E1CF82-4934-36F0-E85C-875C5D937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2DEC35-D8A5-5545-6178-D4C23986E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47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3D9EB-A7D3-A56A-5772-ECA4C045D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DF2A66-A1EC-7833-00FE-591738F6D1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1A1207-E44E-CD1F-260E-6DF53F2FC9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E74EF1-ED61-C589-9EB6-E93FE77A6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D75B20-085D-E086-869E-E4B99F90D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7DE802-5E90-98F4-7618-A5BD33A4E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4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59F36-6BF6-0A8F-B143-5BE575C03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0B1FDF-D5A9-54EA-4129-D3F071605E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16D730-685A-DAB6-757C-87C939A2B0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50AB59-2D3A-C929-6EE5-F55CD6F8A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DD42B8-2070-C0FE-6721-4920EC786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309299-6BCE-5C11-CAC9-38F77A5FB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62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E902D67-CDB4-30EA-890B-5765DF204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50F4BF-C2DE-72D5-F723-BF2040228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7AE20E-4B1D-7917-BBAF-92B0B1FDA8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C514A-C776-4EBA-A33B-E8B708BE5A80}" type="datetimeFigureOut">
              <a:rPr lang="en-US" smtClean="0"/>
              <a:t>2023-11-3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B430D-174B-327C-13C4-4C44481BD4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20CF0-B666-52C6-3BA8-21B7CE40F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D073D-45CA-4E75-80A9-853E0EF99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615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A72D5B0-D140-BC5E-0F69-26FCE7CA77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4306098"/>
              </p:ext>
            </p:extLst>
          </p:nvPr>
        </p:nvGraphicFramePr>
        <p:xfrm>
          <a:off x="866274" y="505327"/>
          <a:ext cx="10327105" cy="607258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78831">
                  <a:extLst>
                    <a:ext uri="{9D8B030D-6E8A-4147-A177-3AD203B41FA5}">
                      <a16:colId xmlns:a16="http://schemas.microsoft.com/office/drawing/2014/main" val="2915164891"/>
                    </a:ext>
                  </a:extLst>
                </a:gridCol>
                <a:gridCol w="880395">
                  <a:extLst>
                    <a:ext uri="{9D8B030D-6E8A-4147-A177-3AD203B41FA5}">
                      <a16:colId xmlns:a16="http://schemas.microsoft.com/office/drawing/2014/main" val="2383085145"/>
                    </a:ext>
                  </a:extLst>
                </a:gridCol>
                <a:gridCol w="3995274">
                  <a:extLst>
                    <a:ext uri="{9D8B030D-6E8A-4147-A177-3AD203B41FA5}">
                      <a16:colId xmlns:a16="http://schemas.microsoft.com/office/drawing/2014/main" val="3459384202"/>
                    </a:ext>
                  </a:extLst>
                </a:gridCol>
                <a:gridCol w="2572605">
                  <a:extLst>
                    <a:ext uri="{9D8B030D-6E8A-4147-A177-3AD203B41FA5}">
                      <a16:colId xmlns:a16="http://schemas.microsoft.com/office/drawing/2014/main" val="3317565633"/>
                    </a:ext>
                  </a:extLst>
                </a:gridCol>
              </a:tblGrid>
              <a:tr h="36629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am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Protein chang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ndition(s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linical significance (Last reviewed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127532275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46G&gt;C (p.Asp316His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316H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Jul 14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3263225252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46G&gt;A (p.Asp316Asn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316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Nov 30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175381458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47A&gt;G (p.Asp316Gly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316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Mar 25, 2022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528029705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NM_002691.4(POLD1):c.952G&gt;C (p.Glu318Gln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318Q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Aug 26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1605045457"/>
                  </a:ext>
                </a:extLst>
              </a:tr>
              <a:tr h="47804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52G&gt;A (p.Glu318Lys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318K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Nov 29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244345013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53A&gt;G (p.Glu318Gly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318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May 18, 2017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82724819"/>
                  </a:ext>
                </a:extLst>
              </a:tr>
              <a:tr h="47804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953A&gt;C (p.Glu318Ala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318A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Uncertain significance (Last reviewed: Nov 2, 2021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959761819"/>
                  </a:ext>
                </a:extLst>
              </a:tr>
              <a:tr h="47804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1204G&gt;T (p.Asp402Tyr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402Y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Aug 27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4289855117"/>
                  </a:ext>
                </a:extLst>
              </a:tr>
              <a:tr h="47804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1204G&gt;A (p.Asp402Asn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402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Dec 16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763701187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1205A&gt;T (p.Asp402Val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402V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Sep 2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821559618"/>
                  </a:ext>
                </a:extLst>
              </a:tr>
              <a:tr h="47804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1205A&gt;G (p.Asp402Gly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402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ereditary cancer-predisposing syndrome</a:t>
                      </a: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Feb 9, 2022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1281528529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NM_002691.4(POLD1):c.1543G&gt;A (p.Asp515Asn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515N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ncertain significance (Last reviewed: Aug 26, 2021)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2745010463"/>
                  </a:ext>
                </a:extLst>
              </a:tr>
              <a:tr h="36629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NM_002691.4(POLD1):c.1544A&gt;G (p.Asp515Gly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515G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olorectal cancer, susceptibility to, 10</a:t>
                      </a:r>
                      <a:endParaRPr lang="en-US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Uncertain significance (Last reviewed: Oct 11, 2021)</a:t>
                      </a:r>
                      <a:endParaRPr lang="en-US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84" marR="29784" marT="0" marB="0"/>
                </a:tc>
                <a:extLst>
                  <a:ext uri="{0D108BD9-81ED-4DB2-BD59-A6C34878D82A}">
                    <a16:rowId xmlns:a16="http://schemas.microsoft.com/office/drawing/2014/main" val="1170321017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D6C6421E-982A-C8E3-E993-470B4B4DBE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9128" y="137302"/>
            <a:ext cx="950002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S1: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mmary of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inVar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atabase search of all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LD1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F0F0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riants with charge-discordant amino acid change in the DEDD motif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5548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BC87A6B-881B-8732-877D-2672AA042D4F}"/>
              </a:ext>
            </a:extLst>
          </p:cNvPr>
          <p:cNvSpPr txBox="1"/>
          <p:nvPr/>
        </p:nvSpPr>
        <p:spPr>
          <a:xfrm>
            <a:off x="104327" y="133852"/>
            <a:ext cx="4308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B83339-B7B7-CF79-C40F-0D8C76BE0811}"/>
              </a:ext>
            </a:extLst>
          </p:cNvPr>
          <p:cNvSpPr txBox="1"/>
          <p:nvPr/>
        </p:nvSpPr>
        <p:spPr>
          <a:xfrm>
            <a:off x="6890899" y="173204"/>
            <a:ext cx="4308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DA0FBB9-A96F-9036-1E99-CDC5C7269A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18710" y="673780"/>
            <a:ext cx="4671771" cy="2048264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1EED266-46AC-45A9-79E6-75ACC7E321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371" y="597568"/>
            <a:ext cx="4737034" cy="544629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DC4430F-3587-2380-5F33-6481E7314BCF}"/>
              </a:ext>
            </a:extLst>
          </p:cNvPr>
          <p:cNvSpPr txBox="1"/>
          <p:nvPr/>
        </p:nvSpPr>
        <p:spPr>
          <a:xfrm>
            <a:off x="6208295" y="4997116"/>
            <a:ext cx="574307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1:  </a:t>
            </a:r>
            <a:r>
              <a:rPr lang="en-US" sz="1400" dirty="0"/>
              <a:t>PRISMA flow chart of systematic analysis of existing literatures reporting genotypic-phenotypic association of germline </a:t>
            </a:r>
            <a:r>
              <a:rPr lang="en-US" sz="1400" i="1" dirty="0"/>
              <a:t>POLD1</a:t>
            </a:r>
            <a:r>
              <a:rPr lang="en-US" sz="1400" dirty="0"/>
              <a:t> mutation in human.</a:t>
            </a:r>
          </a:p>
          <a:p>
            <a:endParaRPr lang="en-US" sz="1400" dirty="0"/>
          </a:p>
          <a:p>
            <a:r>
              <a:rPr lang="en-US" sz="1400" b="1" dirty="0"/>
              <a:t>Supplemental Figure 2:  </a:t>
            </a:r>
            <a:r>
              <a:rPr lang="en-US" sz="1400" dirty="0"/>
              <a:t>Lollipop figure showing the location of </a:t>
            </a:r>
            <a:r>
              <a:rPr lang="en-US" sz="1400" i="1" dirty="0"/>
              <a:t>POLD1</a:t>
            </a:r>
            <a:r>
              <a:rPr lang="en-US" sz="1400" dirty="0"/>
              <a:t> mutation in </a:t>
            </a:r>
            <a:r>
              <a:rPr lang="en-US" sz="1400" i="1" dirty="0"/>
              <a:t>POLD1</a:t>
            </a:r>
            <a:r>
              <a:rPr lang="en-US" sz="1400" dirty="0"/>
              <a:t> wildtype and p.D402N overexpressing endometrial cancer cell lines at passage 20, verified by whole exome sequencing.</a:t>
            </a:r>
          </a:p>
        </p:txBody>
      </p:sp>
    </p:spTree>
    <p:extLst>
      <p:ext uri="{BB962C8B-B14F-4D97-AF65-F5344CB8AC3E}">
        <p14:creationId xmlns:p14="http://schemas.microsoft.com/office/powerpoint/2010/main" val="2407445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61</Words>
  <Application>Microsoft Office PowerPoint</Application>
  <PresentationFormat>Widescreen</PresentationFormat>
  <Paragraphs>6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Wei MD</dc:creator>
  <cp:lastModifiedBy>MDPI</cp:lastModifiedBy>
  <cp:revision>2</cp:revision>
  <dcterms:created xsi:type="dcterms:W3CDTF">2023-11-08T21:17:31Z</dcterms:created>
  <dcterms:modified xsi:type="dcterms:W3CDTF">2023-11-30T14:22:35Z</dcterms:modified>
</cp:coreProperties>
</file>